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979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90D4C-7136-42D7-9EC1-37BCB8F575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A537BE-DD69-40D8-AECE-DCC78B24FA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1A2C6A-B157-453A-AD43-2B05ADF6F3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681964-E972-4A60-A3E0-588B01AAF7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0F8A8E-73CF-4E20-A423-706C0EF146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21A3DE-B948-45A3-9620-11C9D22282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ADBE15-86B5-4E79-B490-7E59111092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742B78-45DE-4B80-B545-46D0582BAD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2903A5-5FE9-4341-A4E6-35543E334F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6C9DB-1FE8-41DD-88CE-A85E3BA999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D89DC-0836-463A-B29B-05790A333E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59BBAE-9850-4A43-939C-4583FEAD3A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986871-AACD-4265-BA50-72B6A36E487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124080" y="5410080"/>
            <a:ext cx="3812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276720" y="5445000"/>
            <a:ext cx="2587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657600" y="5410080"/>
            <a:ext cx="7632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791320" y="5410080"/>
            <a:ext cx="7596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57200" y="533412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mNaipa/b/e/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124080" y="6172200"/>
            <a:ext cx="3812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276720" y="6207120"/>
            <a:ext cx="2587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791320" y="6172200"/>
            <a:ext cx="7596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57200" y="609588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mNaipe/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124080" y="5781600"/>
            <a:ext cx="3812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276720" y="5816520"/>
            <a:ext cx="2587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657600" y="5781600"/>
            <a:ext cx="7632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791320" y="5781600"/>
            <a:ext cx="7596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191120" y="5781600"/>
            <a:ext cx="7596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172040" y="5781600"/>
            <a:ext cx="75960" cy="76320"/>
          </a:xfrm>
          <a:prstGeom prst="rect">
            <a:avLst/>
          </a:prstGeom>
          <a:solidFill>
            <a:srgbClr val="bbe0e3"/>
          </a:solidFill>
          <a:ln w="93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962520" y="5562720"/>
            <a:ext cx="761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AS-L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57200" y="573084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mNaip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28600" y="5257800"/>
            <a:ext cx="8610480" cy="0"/>
          </a:xfrm>
          <a:prstGeom prst="line">
            <a:avLst/>
          </a:prstGeom>
          <a:ln w="936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28600" y="4983120"/>
            <a:ext cx="502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ouse Naip Open Reading Frame Splice Isoform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971800" y="533520"/>
            <a:ext cx="152280" cy="7596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124080" y="566640"/>
            <a:ext cx="3505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5602320" y="533520"/>
            <a:ext cx="3636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6477120" y="533520"/>
            <a:ext cx="22860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502240" y="304920"/>
            <a:ext cx="380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971800" y="685800"/>
            <a:ext cx="152280" cy="7632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124080" y="719280"/>
            <a:ext cx="3505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477120" y="685800"/>
            <a:ext cx="22860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28600" y="274680"/>
            <a:ext cx="8610480" cy="0"/>
          </a:xfrm>
          <a:prstGeom prst="line">
            <a:avLst/>
          </a:prstGeom>
          <a:ln w="936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28600" y="0"/>
            <a:ext cx="502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Mouse Naip 5’ UTR Splice Isoform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57200" y="45720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mNaip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971800" y="1235160"/>
            <a:ext cx="152280" cy="7596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124080" y="1266840"/>
            <a:ext cx="358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419720" y="1235160"/>
            <a:ext cx="7596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6477120" y="1235160"/>
            <a:ext cx="22860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57200" y="114300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mNaip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048120" y="1387440"/>
            <a:ext cx="75960" cy="7632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124080" y="1419120"/>
            <a:ext cx="358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419720" y="1387440"/>
            <a:ext cx="7596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6477120" y="1387440"/>
            <a:ext cx="22860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124080" y="1571760"/>
            <a:ext cx="358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419720" y="1539720"/>
            <a:ext cx="7596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477120" y="1539720"/>
            <a:ext cx="22860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048120" y="1539720"/>
            <a:ext cx="152280" cy="7632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048120" y="1828800"/>
            <a:ext cx="75960" cy="7632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124080" y="1860480"/>
            <a:ext cx="358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352680" y="1828800"/>
            <a:ext cx="7632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6477120" y="1828800"/>
            <a:ext cx="22860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6324480" y="33804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048120" y="1676520"/>
            <a:ext cx="75960" cy="7596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124080" y="1708200"/>
            <a:ext cx="35816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581280" y="1676520"/>
            <a:ext cx="76320" cy="75960"/>
          </a:xfrm>
          <a:prstGeom prst="rect">
            <a:avLst/>
          </a:prstGeom>
          <a:solidFill>
            <a:srgbClr val="bbe0e3"/>
          </a:solidFill>
          <a:ln w="93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6477120" y="1676520"/>
            <a:ext cx="22860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419720" y="1676520"/>
            <a:ext cx="7596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537000" y="1676520"/>
            <a:ext cx="7632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457200" y="220824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mNai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970360" y="2360520"/>
            <a:ext cx="245880" cy="7632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230640" y="2398680"/>
            <a:ext cx="324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6388200" y="2360520"/>
            <a:ext cx="201600" cy="76320"/>
          </a:xfrm>
          <a:prstGeom prst="rect">
            <a:avLst/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6477120" y="2360520"/>
            <a:ext cx="22860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971800" y="2513160"/>
            <a:ext cx="182520" cy="7596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152880" y="2550960"/>
            <a:ext cx="3427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6389640" y="2513160"/>
            <a:ext cx="201600" cy="75960"/>
          </a:xfrm>
          <a:prstGeom prst="rect">
            <a:avLst/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6478560" y="2513160"/>
            <a:ext cx="22860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3033720" y="2665440"/>
            <a:ext cx="182520" cy="7632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232080" y="2703600"/>
            <a:ext cx="3245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6389640" y="2665440"/>
            <a:ext cx="201600" cy="76320"/>
          </a:xfrm>
          <a:prstGeom prst="rect">
            <a:avLst/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6478560" y="2665440"/>
            <a:ext cx="22860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048120" y="2817720"/>
            <a:ext cx="91800" cy="7632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135240" y="2855880"/>
            <a:ext cx="3427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6404040" y="2817720"/>
            <a:ext cx="201600" cy="76320"/>
          </a:xfrm>
          <a:prstGeom prst="rect">
            <a:avLst/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6492960" y="2817720"/>
            <a:ext cx="22860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970360" y="2970360"/>
            <a:ext cx="311040" cy="7596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281400" y="3008160"/>
            <a:ext cx="3336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6499080" y="2970360"/>
            <a:ext cx="21924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2971800" y="3122640"/>
            <a:ext cx="246240" cy="7632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232080" y="3160800"/>
            <a:ext cx="3336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6572160" y="3122640"/>
            <a:ext cx="1364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048120" y="3274920"/>
            <a:ext cx="182520" cy="7632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225960" y="3313080"/>
            <a:ext cx="3363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6572160" y="3274920"/>
            <a:ext cx="1364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457200" y="387036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mNai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3048120" y="3427560"/>
            <a:ext cx="75960" cy="7596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124080" y="3451320"/>
            <a:ext cx="2330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124080" y="3427560"/>
            <a:ext cx="326412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5943600" y="3427560"/>
            <a:ext cx="282600" cy="759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5562720" y="3427560"/>
            <a:ext cx="125280" cy="75960"/>
          </a:xfrm>
          <a:prstGeom prst="rect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6324480" y="3427560"/>
            <a:ext cx="201600" cy="75960"/>
          </a:xfrm>
          <a:prstGeom prst="rect">
            <a:avLst/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6489720" y="3427560"/>
            <a:ext cx="22860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048120" y="3422520"/>
            <a:ext cx="228600" cy="8280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0" bIns="36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970360" y="4114800"/>
            <a:ext cx="245880" cy="7632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230640" y="4152960"/>
            <a:ext cx="324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6388200" y="4114800"/>
            <a:ext cx="201600" cy="76320"/>
          </a:xfrm>
          <a:prstGeom prst="rect">
            <a:avLst/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6477120" y="4114800"/>
            <a:ext cx="22860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230640" y="4000680"/>
            <a:ext cx="324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6388200" y="3962520"/>
            <a:ext cx="201600" cy="75960"/>
          </a:xfrm>
          <a:prstGeom prst="rect">
            <a:avLst/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6477120" y="3962520"/>
            <a:ext cx="22860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971800" y="3962520"/>
            <a:ext cx="311040" cy="7596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3048120" y="4267080"/>
            <a:ext cx="182520" cy="7632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3235320" y="4305240"/>
            <a:ext cx="324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6404040" y="4267080"/>
            <a:ext cx="201600" cy="76320"/>
          </a:xfrm>
          <a:prstGeom prst="rect">
            <a:avLst/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6492960" y="4267080"/>
            <a:ext cx="22860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2970360" y="4419720"/>
            <a:ext cx="245880" cy="75960"/>
          </a:xfrm>
          <a:prstGeom prst="rect">
            <a:avLst/>
          </a:prstGeom>
          <a:solidFill>
            <a:srgbClr val="cc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3230640" y="4457880"/>
            <a:ext cx="324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6477120" y="4419720"/>
            <a:ext cx="22860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2743200" y="36504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ORR1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6095880" y="219384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M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3429000" y="1523880"/>
            <a:ext cx="99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B1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971800" y="524196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971800" y="562284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2971800" y="600408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0" y="3024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0" y="498312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5334120" y="3260880"/>
            <a:ext cx="99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B1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5715000" y="3260880"/>
            <a:ext cx="99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B1_Mus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7-24T22:21:16Z</dcterms:created>
  <dc:creator>mromanis</dc:creator>
  <dc:description/>
  <dc:language>en-US</dc:language>
  <cp:lastModifiedBy>mromanis</cp:lastModifiedBy>
  <dcterms:modified xsi:type="dcterms:W3CDTF">2006-11-30T20:02:08Z</dcterms:modified>
  <cp:revision>16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1897682696</vt:r8>
  </property>
  <property fmtid="{D5CDD505-2E9C-101B-9397-08002B2CF9AE}" pid="3" name="_AuthorEmail">
    <vt:lpwstr>mromanis@bccrc.ca</vt:lpwstr>
  </property>
  <property fmtid="{D5CDD505-2E9C-101B-9397-08002B2CF9AE}" pid="4" name="_AuthorEmailDisplayName">
    <vt:lpwstr>Mark Romanish</vt:lpwstr>
  </property>
  <property fmtid="{D5CDD505-2E9C-101B-9397-08002B2CF9AE}" pid="5" name="_EmailSubject">
    <vt:lpwstr>Synopsis</vt:lpwstr>
  </property>
</Properties>
</file>